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3" d="100"/>
          <a:sy n="63" d="100"/>
        </p:scale>
        <p:origin x="780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2C386EA-DD37-D40A-E031-F1326B7C727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2E4FC9DC-367D-113A-BA89-B7E74D31245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6D4D9C1-4707-9AB2-687D-0B281544E0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6A069-A870-40D7-829F-48434EB08389}" type="datetimeFigureOut">
              <a:rPr lang="zh-CN" altLang="en-US" smtClean="0"/>
              <a:t>2022/9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97554E5-7BA4-6F71-E2B4-C5BB4DCDD7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3E4546D-2872-5CE2-C65F-E2A45F0CCE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83AB1-FB5C-4B75-A5EE-D4E50E2C93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195645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4B0B278-6AD3-69B1-F569-679F47FE2A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0410C07-9C61-33E4-7578-51E6FE5D54E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D38F090-9C9B-9316-EAAA-C681E3FEC3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6A069-A870-40D7-829F-48434EB08389}" type="datetimeFigureOut">
              <a:rPr lang="zh-CN" altLang="en-US" smtClean="0"/>
              <a:t>2022/9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CB9C732-EA57-43A0-697D-90B2F27E8C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A6F7D2A-E69E-14A0-C03B-E2E45B8341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83AB1-FB5C-4B75-A5EE-D4E50E2C93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000607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152DF106-2FC4-3B81-0B51-DBFD5AC8D25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78D0936-B8BD-05C7-21E4-0004F7E7E64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56A6DEA-C20A-4F50-63C0-A58DEFF6B2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6A069-A870-40D7-829F-48434EB08389}" type="datetimeFigureOut">
              <a:rPr lang="zh-CN" altLang="en-US" smtClean="0"/>
              <a:t>2022/9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261E182-EF59-A4D6-68B5-66D4C8A7FB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AF99BF3-702F-090F-B0A0-16DD70C680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83AB1-FB5C-4B75-A5EE-D4E50E2C93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159000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811D003-9008-584A-C0F4-712D932D73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CC48259-F23A-AD3C-037B-5E1F1005272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2E7D590-EBD4-7786-CD52-85146A2843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6A069-A870-40D7-829F-48434EB08389}" type="datetimeFigureOut">
              <a:rPr lang="zh-CN" altLang="en-US" smtClean="0"/>
              <a:t>2022/9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A94222D-DE47-FAF1-CD12-9E099CA58C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D37123C-2E29-FF21-AD73-3632F79ED6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83AB1-FB5C-4B75-A5EE-D4E50E2C93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0342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7082D8C-A28B-6148-AE15-6360F342BA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87A883B-D3F7-2476-0D4A-B2125F4A10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AD9A3BB-1AFE-D1A9-FFDC-C554DB3971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6A069-A870-40D7-829F-48434EB08389}" type="datetimeFigureOut">
              <a:rPr lang="zh-CN" altLang="en-US" smtClean="0"/>
              <a:t>2022/9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08D412A-6B20-C0ED-53B8-88514FC2D7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039ADBA-2EF9-769E-7C91-8CBEFBE2DA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83AB1-FB5C-4B75-A5EE-D4E50E2C93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590191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6E87AA0-25D3-9660-55FB-72790D807F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5E42DA2-A00A-2546-8135-85568BFB358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8014174-49C2-EE2A-2340-3B48D55D95B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68EE80D-34C6-51CE-1E78-699F9DE495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6A069-A870-40D7-829F-48434EB08389}" type="datetimeFigureOut">
              <a:rPr lang="zh-CN" altLang="en-US" smtClean="0"/>
              <a:t>2022/9/2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C6705A1-934E-D82F-CEA8-513812F5EF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C8CCF77-5F9C-E726-49D8-069ACCEE35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83AB1-FB5C-4B75-A5EE-D4E50E2C93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349646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AD6F003-2C9A-ED99-15AB-A590A0C7B8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6F6A60F-9982-C89F-D274-7D3AB9D70C3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FC14185-AD5B-A5ED-5BBB-929AC65188E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8840B254-BC57-27BD-5902-F7136AC2B98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E541736A-5561-0703-86BE-758D2BE7584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8C162F15-8D21-D0E8-53F1-1E74266982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6A069-A870-40D7-829F-48434EB08389}" type="datetimeFigureOut">
              <a:rPr lang="zh-CN" altLang="en-US" smtClean="0"/>
              <a:t>2022/9/2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3AE421F5-4317-719B-3563-C94887D1A2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5FA8EDE2-C7D9-44B4-86BD-959B3F8E55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83AB1-FB5C-4B75-A5EE-D4E50E2C93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999147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6D3AA82-0B9B-6121-5BEF-B63D4ED180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79F99A68-C2B8-936A-F47F-293A26AC90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6A069-A870-40D7-829F-48434EB08389}" type="datetimeFigureOut">
              <a:rPr lang="zh-CN" altLang="en-US" smtClean="0"/>
              <a:t>2022/9/2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128EB310-B23A-F760-2CEE-3066952703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E798D866-3E92-ECFC-27C1-D41CF6A6F7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83AB1-FB5C-4B75-A5EE-D4E50E2C93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730810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0D99AA24-025E-5CAD-9CB6-7C7FDF43E2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6A069-A870-40D7-829F-48434EB08389}" type="datetimeFigureOut">
              <a:rPr lang="zh-CN" altLang="en-US" smtClean="0"/>
              <a:t>2022/9/2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BA1F0382-2439-C95C-B27E-0C014B2E26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A3BE0DF7-0A58-4F1D-3032-B089354E8C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83AB1-FB5C-4B75-A5EE-D4E50E2C93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162386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46BCCAC-F6C9-DC0E-9B9E-1247F490CF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7F32408-0B05-A7CE-B6B7-013C7AA1D84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6ACCA7E-5A41-4923-AE98-8DFD9786E0A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8A562EC-4728-0DD2-8AC2-85BE8CF5A4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6A069-A870-40D7-829F-48434EB08389}" type="datetimeFigureOut">
              <a:rPr lang="zh-CN" altLang="en-US" smtClean="0"/>
              <a:t>2022/9/2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06E56D7-8FB4-D211-8686-C3C3637A95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4F96FCD-F9A7-95D4-054B-06B68A4C1A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83AB1-FB5C-4B75-A5EE-D4E50E2C93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32462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BAD3C87-0C82-A6D7-EB03-5EBE27C267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D3DD488D-A1ED-D074-26B4-81034A06147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F049AA6-7F59-909D-E95F-41E1F8E9902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DFB2407-E0F7-F364-C95B-14E8A87726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6A069-A870-40D7-829F-48434EB08389}" type="datetimeFigureOut">
              <a:rPr lang="zh-CN" altLang="en-US" smtClean="0"/>
              <a:t>2022/9/2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36D0C98-F05F-6E99-B294-EEA4EC7E8C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A36D69D-F33B-79CA-31AB-AFEEACC6EC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83AB1-FB5C-4B75-A5EE-D4E50E2C93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97050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A7FEBE2E-AF6B-9DDC-00B4-67AC459F4F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55AE534-B861-ABF0-2476-49690131BC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748D01D-CAAF-C57E-9F6B-9018037BB08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D6A069-A870-40D7-829F-48434EB08389}" type="datetimeFigureOut">
              <a:rPr lang="zh-CN" altLang="en-US" smtClean="0"/>
              <a:t>2022/9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FC772EB-7C7A-5E8A-BFD9-79B45CC5B18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31D492A-D475-E62A-C89B-7D62AA9ADE3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B83AB1-FB5C-4B75-A5EE-D4E50E2C93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56985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D65A534D-F191-55FE-D3AE-05C0A214069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85872" y="367792"/>
            <a:ext cx="6266688" cy="4160946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263657C5-EC00-E363-BD5D-10835B7662C7}"/>
              </a:ext>
            </a:extLst>
          </p:cNvPr>
          <p:cNvSpPr txBox="1"/>
          <p:nvPr/>
        </p:nvSpPr>
        <p:spPr>
          <a:xfrm>
            <a:off x="1979745" y="4861914"/>
            <a:ext cx="8232509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800" b="1" kern="100" dirty="0">
                <a:solidFill>
                  <a:srgbClr val="000000"/>
                </a:solidFill>
                <a:effectLst/>
                <a:latin typeface="等线" panose="02010600030101010101" pitchFamily="2" charset="-122"/>
                <a:ea typeface="等线" panose="02010600030101010101" pitchFamily="2" charset="-122"/>
                <a:cs typeface="Mongolian Baiti" panose="03000500000000000000" pitchFamily="66" charset="0"/>
              </a:rPr>
              <a:t>Supplementary Figure 1. </a:t>
            </a:r>
            <a:r>
              <a:rPr lang="en-US" altLang="zh-CN" sz="1800" b="1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Mongolian Baiti" panose="03000500000000000000" pitchFamily="66" charset="0"/>
              </a:rPr>
              <a:t>A brief diagram of ncRNAs in regulating the balance between plant growth and development and abiotic stress resistance. </a:t>
            </a:r>
            <a:r>
              <a:rPr lang="en-US" altLang="zh-CN" sz="18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Mongolian Baiti" panose="03000500000000000000" pitchFamily="66" charset="0"/>
              </a:rPr>
              <a:t>There may exist a trade-off between plant resistance and growth. The phytohormones involved in plant development and abiotic stress responses also play important roles in this regulation.</a:t>
            </a:r>
            <a:endParaRPr lang="zh-CN" altLang="zh-CN" sz="18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Mongolian Baiti" panose="03000500000000000000" pitchFamily="66" charset="0"/>
            </a:endParaRPr>
          </a:p>
          <a:p>
            <a:pPr algn="just"/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3722608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CEEACA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52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heng fang</dc:creator>
  <cp:lastModifiedBy>cheng fang</cp:lastModifiedBy>
  <cp:revision>1</cp:revision>
  <dcterms:created xsi:type="dcterms:W3CDTF">2022-09-27T12:18:20Z</dcterms:created>
  <dcterms:modified xsi:type="dcterms:W3CDTF">2022-09-27T12:19:39Z</dcterms:modified>
</cp:coreProperties>
</file>